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07995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44911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2/03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ory J. McCrimmon (2021) Diabetologia DOI 10.1007/s00125-020-05369-0 </a:t>
            </a:r>
          </a:p>
          <a:p>
            <a:r>
              <a:rPr lang="en-GB" sz="1200" dirty="0"/>
              <a:t>© The Author 202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otential mechanisms of cerebral adaptation to recurrent hypoglycaemi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6BDB4C2-CC86-4A67-AF96-B72F1970620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4087" y="764704"/>
            <a:ext cx="7015826" cy="5030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ory J. McCrimmon (2021) Diabetologia DOI 10.1007/s00125-020-05369-0 </a:t>
            </a:r>
          </a:p>
          <a:p>
            <a:r>
              <a:rPr lang="en-GB" sz="1200" dirty="0"/>
              <a:t>© The Author 202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hifting thresholds for hypoglycaemia detect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5C10D95-8CF7-48E0-8269-A25A604445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0738" y="1268760"/>
            <a:ext cx="7002524" cy="3973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06009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899338"/>
            <a:ext cx="799288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ory J. McCrimmon (2021) Diabetologia DOI 10.1007/s00125-020-05369-0 </a:t>
            </a:r>
          </a:p>
          <a:p>
            <a:r>
              <a:rPr lang="en-GB" sz="1200" dirty="0"/>
              <a:t>© The Author 202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Impact of glycaemic variability, hypoglycaemia and hypoglycaemia recovery on the brai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0612F69-E494-454F-BB7D-37BC989E7D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5840" y="1491761"/>
            <a:ext cx="7452320" cy="3539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6478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2</TotalTime>
  <Words>76</Words>
  <Application>Microsoft Office PowerPoint</Application>
  <PresentationFormat>On-screen Show (4:3)</PresentationFormat>
  <Paragraphs>14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udy Naylor</cp:lastModifiedBy>
  <cp:revision>40</cp:revision>
  <dcterms:created xsi:type="dcterms:W3CDTF">2016-06-15T12:53:43Z</dcterms:created>
  <dcterms:modified xsi:type="dcterms:W3CDTF">2021-03-12T11:46:58Z</dcterms:modified>
</cp:coreProperties>
</file>